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6738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31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0806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3081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4803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162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0927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9037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9930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3954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9173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0BD9B-2F28-48BC-825E-E27449734716}" type="datetimeFigureOut">
              <a:rPr lang="ko-KR" altLang="en-US" smtClean="0"/>
              <a:t>2025-10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0C27E-5EDE-45D6-899B-05C6214686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4623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D2429D-3AEF-9B74-3E8B-992B197819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CFB0D9F-AAA0-316D-8D60-339E50D36616}"/>
              </a:ext>
            </a:extLst>
          </p:cNvPr>
          <p:cNvSpPr txBox="1"/>
          <p:nvPr/>
        </p:nvSpPr>
        <p:spPr>
          <a:xfrm>
            <a:off x="295610" y="5377549"/>
            <a:ext cx="1128272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. </a:t>
            </a:r>
            <a:r>
              <a:rPr lang="en-US" altLang="ko-KR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djusted odds ratios for 30-day in-hospital mortality by time to initial glycopeptide therapy in MRSA bacteremia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(excluding patients who received antibiotics after 120 h)</a:t>
            </a:r>
          </a:p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djusted odds ratios (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aORs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) are shown relative to the group that did not receive glycopeptide therapy. Arrows indicate that the upper 95% confidence limit exceeds the axis range (truncated at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aOR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= 6). CI, confidence interval; GT, glycopeptide therapy; MRSA, methicillin-resistant </a:t>
            </a:r>
            <a:r>
              <a:rPr lang="en-US" altLang="ko-KR" sz="1600" i="1" dirty="0">
                <a:latin typeface="Arial" panose="020B0604020202020204" pitchFamily="34" charset="0"/>
                <a:cs typeface="Arial" panose="020B0604020202020204" pitchFamily="34" charset="0"/>
              </a:rPr>
              <a:t>S. aureus.</a:t>
            </a:r>
            <a:endParaRPr lang="ko-KR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 descr="텍스트, 도표, 스크린샷, 라인이(가) 표시된 사진&#10;&#10;AI가 생성한 콘텐츠는 부정확할 수 있습니다.">
            <a:extLst>
              <a:ext uri="{FF2B5EF4-FFF2-40B4-BE49-F238E27FC236}">
                <a16:creationId xmlns:a16="http://schemas.microsoft.com/office/drawing/2014/main" id="{23946B1C-59E6-BC9C-82B3-D7F653FE1E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6738" y="834064"/>
            <a:ext cx="6478524" cy="4319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9890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2</TotalTime>
  <Words>87</Words>
  <Application>Microsoft Office PowerPoint</Application>
  <PresentationFormat>와이드스크린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paik</dc:creator>
  <cp:lastModifiedBy>Seok Jun Mun</cp:lastModifiedBy>
  <cp:revision>87</cp:revision>
  <dcterms:created xsi:type="dcterms:W3CDTF">2020-03-13T08:47:50Z</dcterms:created>
  <dcterms:modified xsi:type="dcterms:W3CDTF">2025-10-01T00:26:56Z</dcterms:modified>
</cp:coreProperties>
</file>